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608535-85E4-4E71-ABC0-BC5019CA1013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8A1B9A-263F-42C9-BF18-7998945A05B1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6353D-54BB-4C16-909C-94AB509505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CC8D7-6407-4E04-8942-A49EBE8F52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46161-50AB-45ED-AF08-35398A355D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234B9-9B2C-4162-860C-8CD114B086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52F72-AC3B-4D74-9F2D-C883168221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D9339-E1C4-4277-90CC-6602DD2692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AC73F-179C-49DC-8394-12EB4B3803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0C163-692E-4443-BBD2-F9E8983B12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B8C9B-0306-4E5F-B317-036BE5E456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6F39BD-EF71-444E-923A-B0E095CD9D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A0890-1BBA-4F2E-A87C-808CDEB85A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0CAF7-D1A7-42F8-987E-E4575B9E91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6C1527-6738-4BEB-AE20-39438226F610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250920" y="333360"/>
          <a:ext cx="8569080" cy="6194520"/>
        </p:xfrm>
        <a:graphic>
          <a:graphicData uri="http://schemas.openxmlformats.org/drawingml/2006/table">
            <a:tbl>
              <a:tblPr/>
              <a:tblGrid>
                <a:gridCol w="857160"/>
                <a:gridCol w="2765520"/>
                <a:gridCol w="2263680"/>
                <a:gridCol w="1857240"/>
                <a:gridCol w="825480"/>
              </a:tblGrid>
              <a:tr h="28476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m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thoge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mer sequence (5'-3')                                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</a:t>
                      </a:r>
                      <a:r>
                        <a:rPr b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Species-specific ge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ize (b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7720">
                <a:tc rowSpan="26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acter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Vibri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 </a:t>
                      </a:r>
                      <a:r>
                        <a:rPr b="1" lang="zh-CN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（</a:t>
                      </a:r>
                      <a:r>
                        <a:rPr b="1" i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Vibrio parahemolyticus</a:t>
                      </a:r>
                      <a:r>
                        <a:rPr b="1" i="1" lang="zh-CN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，</a:t>
                      </a:r>
                      <a:r>
                        <a:rPr b="1" i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Vibrio minicus, Vibrio cholerae and Vibrio fluvialis</a:t>
                      </a:r>
                      <a:r>
                        <a:rPr b="1" lang="zh-CN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）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ACATCACCCATGACGGT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rp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GGGCTGAAAGTGGCATCG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. typhimuriu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CGTCTTCAGCGACCAGT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AERV01000023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ATCTTAAGCTACATCATCGGC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. enteritid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TGTGTTTTATCTGATGCAAG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AF370707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GCTCGCTGCACAAAAGC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higell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CATGCCTGAACAACGAGTT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vi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TGCGATGGTAATATTGATGAGCTAA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. diffic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TAGCTGAGTCTGAAGGAGCAT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  </a:t>
                      </a:r>
                      <a:r>
                        <a:rPr b="0" i="1" lang="en-US" sz="9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tcd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TATATGTTATTGATGGTGATGAAAAG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. jejun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TCCTTCTTTTAAATCATAAAATCTAT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map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ACAAGATACTTTTGCTCAAGTTAAT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. enterocoliti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ACCTGAAGTACCGTTATGAACTCGATGA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ai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CATATTCGT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GCGGAAAGA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P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GCGATTACGCGAAA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ea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AGGAACAAACGCTGGC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GATTACATCGTAACAGGGAATATAG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el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CATTACAAGTATCACCTGTAATT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A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ACACAAAAGAAGGAAGCAATA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agg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TTGAATCATCATTATGATCGATACT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I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CAGGGAAATGTTCCGC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ipa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AGAGCTGAAGTTTCTCT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4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H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ACATCGGTGTCTGTTATTAAC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stx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TTGCCGTATTAACGAACCCG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.Coli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1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CTCTGCGGTCCTAGTTAGAA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rf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TTGGCATGACGTTATAGGCTA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rowSpan="1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irus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3d3d3d"/>
                          </a:solidFill>
                          <a:latin typeface="Times New Roman"/>
                          <a:ea typeface="Times New Roman"/>
                        </a:rPr>
                        <a:t>Norovir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ACCCCTGGATTAGAACAAAT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V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CGGCGGCGAAGAGGATC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tavirus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GAGGGTTTG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TGATAGA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V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CTTAT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TGAAAAAAGTAGCTGT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tavirus 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CTCTCACATATGGAGTATTAGC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V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GGATGCAA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TGATATCTTATTAT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tavirus 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TGTCAAGCTATGATGTTCACAATTT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V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GGTGATG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TAATT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TAAT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enovir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CAACATCGGCACCCCTC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fi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GGACCAAGATTGATTATTAACTTAGA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trovirus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TA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ACAGCCCGGA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capsid protein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5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GTGC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GGTGTTTG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9240">
                <a:tc rowSpan="6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um_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 GATGAGTATGCCTGCCG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B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26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 </a:t>
                      </a:r>
                      <a:r>
                        <a:rPr b="0" lang="en-US" sz="800" spc="-1" strike="noStrike">
                          <a:solidFill>
                            <a:srgbClr val="0d0d0d"/>
                          </a:solidFill>
                          <a:latin typeface="Times New Roman"/>
                        </a:rPr>
                        <a:t>ATGCGGCATCTTCAAAC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um_D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 </a:t>
                      </a:r>
                      <a:r>
                        <a:rPr b="0" lang="en-US" sz="800" spc="-1" strike="noStrike">
                          <a:solidFill>
                            <a:srgbClr val="0d0d0d"/>
                          </a:solidFill>
                          <a:latin typeface="Times New Roman"/>
                        </a:rPr>
                        <a:t>GTGGATGCTACTTGTCCAATG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ts val="998"/>
                        </a:lnSpc>
                        <a:spcBef>
                          <a:spcPts val="10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  <a:ea typeface="Times New Roman"/>
                        </a:rPr>
                        <a:t>RNase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 </a:t>
                      </a:r>
                      <a:r>
                        <a:rPr b="0" lang="en-US" sz="800" spc="-1" strike="noStrike">
                          <a:solidFill>
                            <a:srgbClr val="0d0d0d"/>
                          </a:solidFill>
                          <a:latin typeface="Times New Roman"/>
                        </a:rPr>
                        <a:t>ACAATTCTCCGATCCGTCCCT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0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: </a:t>
                      </a:r>
                      <a:r>
                        <a:rPr b="0" lang="en-US" sz="800" spc="-1" strike="noStrike">
                          <a:solidFill>
                            <a:srgbClr val="0d0d0d"/>
                          </a:solidFill>
                          <a:latin typeface="Times New Roman"/>
                        </a:rPr>
                        <a:t>GTGGCCGCTTTTCTGGATTC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                  </a:t>
                      </a:r>
                      <a:r>
                        <a:rPr b="0" i="1" lang="en-US" sz="1000" spc="-1" strike="noStrike">
                          <a:solidFill>
                            <a:srgbClr val="00b0f0"/>
                          </a:solidFill>
                          <a:latin typeface="Times New Roman"/>
                        </a:rPr>
                        <a:t>modified Kan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7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: </a:t>
                      </a:r>
                      <a:r>
                        <a:rPr b="0" lang="en-US" sz="800" spc="-1" strike="noStrike">
                          <a:solidFill>
                            <a:srgbClr val="0d0d0d"/>
                          </a:solidFill>
                          <a:latin typeface="Times New Roman"/>
                        </a:rPr>
                        <a:t>TGAAGGCACAGTCGAGGC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9" name="TextBox 4"/>
          <p:cNvSpPr/>
          <p:nvPr/>
        </p:nvSpPr>
        <p:spPr>
          <a:xfrm>
            <a:off x="1285920" y="0"/>
            <a:ext cx="671508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23760" y="-27000"/>
            <a:ext cx="7572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b0f0"/>
                </a:solidFill>
                <a:latin typeface="Times New Roman"/>
                <a:ea typeface="Times New Roman"/>
              </a:rPr>
              <a:t>Table S1. Species-specific genes, primer sequences and product size of PD in DP-HMG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矩形 4"/>
          <p:cNvSpPr/>
          <p:nvPr/>
        </p:nvSpPr>
        <p:spPr>
          <a:xfrm>
            <a:off x="287280" y="6567480"/>
            <a:ext cx="896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highlighted base corresponds to degenerate bases as follows: Y(C/T), R(A/G)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i="1" lang="en-US" sz="1000" spc="-1" strike="noStrike">
                <a:solidFill>
                  <a:srgbClr val="00b0f0"/>
                </a:solidFill>
                <a:latin typeface="Times New Roman"/>
                <a:ea typeface="Times New Roman"/>
              </a:rPr>
              <a:t>The  concentrations of each primer is 1µM in DP-HMGS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30T03:31:31Z</dcterms:created>
  <dc:creator>pc</dc:creator>
  <dc:description/>
  <dc:language>en-US</dc:language>
  <cp:lastModifiedBy>pc</cp:lastModifiedBy>
  <dcterms:modified xsi:type="dcterms:W3CDTF">2018-07-24T05:24:37Z</dcterms:modified>
  <cp:revision>34</cp:revision>
  <dc:subject/>
  <dc:title>幻灯片 1</dc:title>
</cp:coreProperties>
</file>